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1426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174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795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957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136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760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551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626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607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628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312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765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D5C24-2147-4183-9122-8E58CFB85D8D}" type="datetimeFigureOut">
              <a:rPr lang="en-US" smtClean="0"/>
              <a:t>2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480FF-0038-4FD3-97EA-CC1CAC8EC1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004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71110"/>
            <a:ext cx="90678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1</a:t>
            </a:r>
            <a:r>
              <a:rPr lang="it-IT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 for mouse brain sample treatment. Different extraction and precipitation conditions were tested and the percentage (%) of recovery of the thre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te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veraged for three experiments for each pair of conditions were calculated. Conditions yielding the highest recovery for all thre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te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selected. </a:t>
            </a: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94768" y="1900374"/>
            <a:ext cx="9162568" cy="45766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1910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4</TotalTime>
  <Words>52</Words>
  <Application>Microsoft Office PowerPoint</Application>
  <PresentationFormat>Presentazione su schermo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lient3</dc:creator>
  <cp:lastModifiedBy>Gabriella Pinto</cp:lastModifiedBy>
  <cp:revision>20</cp:revision>
  <dcterms:created xsi:type="dcterms:W3CDTF">2017-01-19T15:56:15Z</dcterms:created>
  <dcterms:modified xsi:type="dcterms:W3CDTF">2017-02-14T17:11:53Z</dcterms:modified>
</cp:coreProperties>
</file>